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98" r:id="rId2"/>
  </p:sldIdLst>
  <p:sldSz cx="7589838" cy="1069816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om DeFalco" initials="TAD" lastIdx="9" clrIdx="0">
    <p:extLst/>
  </p:cmAuthor>
  <p:cmAuthor id="2" name="Christine" initials="C" lastIdx="3" clrIdx="1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FF9933"/>
    <a:srgbClr val="FF6600"/>
    <a:srgbClr val="000099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151" autoAdjust="0"/>
    <p:restoredTop sz="94660"/>
  </p:normalViewPr>
  <p:slideViewPr>
    <p:cSldViewPr snapToGrid="0">
      <p:cViewPr>
        <p:scale>
          <a:sx n="80" d="100"/>
          <a:sy n="80" d="100"/>
        </p:scale>
        <p:origin x="-1074" y="216"/>
      </p:cViewPr>
      <p:guideLst>
        <p:guide orient="horz" pos="3369"/>
        <p:guide pos="239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54AF71-6B0D-4268-8DE5-E904D13FBA94}" type="datetimeFigureOut">
              <a:rPr lang="en-US" smtClean="0"/>
              <a:t>8/21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3625" y="1143000"/>
            <a:ext cx="21907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7B464A9-5B19-4301-BCA5-F20F7B3D91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1275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9238" y="1750834"/>
            <a:ext cx="6451362" cy="3724546"/>
          </a:xfrm>
        </p:spPr>
        <p:txBody>
          <a:bodyPr anchor="b"/>
          <a:lstStyle>
            <a:lvl1pPr algn="ctr">
              <a:defRPr sz="49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8730" y="5619013"/>
            <a:ext cx="5692379" cy="2582912"/>
          </a:xfrm>
        </p:spPr>
        <p:txBody>
          <a:bodyPr/>
          <a:lstStyle>
            <a:lvl1pPr marL="0" indent="0" algn="ctr">
              <a:buNone/>
              <a:defRPr sz="1992"/>
            </a:lvl1pPr>
            <a:lvl2pPr marL="379476" indent="0" algn="ctr">
              <a:buNone/>
              <a:defRPr sz="1660"/>
            </a:lvl2pPr>
            <a:lvl3pPr marL="758952" indent="0" algn="ctr">
              <a:buNone/>
              <a:defRPr sz="1494"/>
            </a:lvl3pPr>
            <a:lvl4pPr marL="1138428" indent="0" algn="ctr">
              <a:buNone/>
              <a:defRPr sz="1328"/>
            </a:lvl4pPr>
            <a:lvl5pPr marL="1517904" indent="0" algn="ctr">
              <a:buNone/>
              <a:defRPr sz="1328"/>
            </a:lvl5pPr>
            <a:lvl6pPr marL="1897380" indent="0" algn="ctr">
              <a:buNone/>
              <a:defRPr sz="1328"/>
            </a:lvl6pPr>
            <a:lvl7pPr marL="2276856" indent="0" algn="ctr">
              <a:buNone/>
              <a:defRPr sz="1328"/>
            </a:lvl7pPr>
            <a:lvl8pPr marL="2656332" indent="0" algn="ctr">
              <a:buNone/>
              <a:defRPr sz="1328"/>
            </a:lvl8pPr>
            <a:lvl9pPr marL="3035808" indent="0" algn="ctr">
              <a:buNone/>
              <a:defRPr sz="132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483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5675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31478" y="569578"/>
            <a:ext cx="1636559" cy="906619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21802" y="569578"/>
            <a:ext cx="4814803" cy="906619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221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2683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7849" y="2667115"/>
            <a:ext cx="6546235" cy="4450138"/>
          </a:xfrm>
        </p:spPr>
        <p:txBody>
          <a:bodyPr anchor="b"/>
          <a:lstStyle>
            <a:lvl1pPr>
              <a:defRPr sz="49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7849" y="7159353"/>
            <a:ext cx="6546235" cy="2340222"/>
          </a:xfrm>
        </p:spPr>
        <p:txBody>
          <a:bodyPr/>
          <a:lstStyle>
            <a:lvl1pPr marL="0" indent="0">
              <a:buNone/>
              <a:defRPr sz="1992">
                <a:solidFill>
                  <a:schemeClr val="tx1"/>
                </a:solidFill>
              </a:defRPr>
            </a:lvl1pPr>
            <a:lvl2pPr marL="379476" indent="0">
              <a:buNone/>
              <a:defRPr sz="1660">
                <a:solidFill>
                  <a:schemeClr val="tx1">
                    <a:tint val="75000"/>
                  </a:schemeClr>
                </a:solidFill>
              </a:defRPr>
            </a:lvl2pPr>
            <a:lvl3pPr marL="758952" indent="0">
              <a:buNone/>
              <a:defRPr sz="1494">
                <a:solidFill>
                  <a:schemeClr val="tx1">
                    <a:tint val="75000"/>
                  </a:schemeClr>
                </a:solidFill>
              </a:defRPr>
            </a:lvl3pPr>
            <a:lvl4pPr marL="1138428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4pPr>
            <a:lvl5pPr marL="1517904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5pPr>
            <a:lvl6pPr marL="1897380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6pPr>
            <a:lvl7pPr marL="2276856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7pPr>
            <a:lvl8pPr marL="2656332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8pPr>
            <a:lvl9pPr marL="3035808" indent="0">
              <a:buNone/>
              <a:defRPr sz="132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8146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21801" y="2847891"/>
            <a:ext cx="3225681" cy="678788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42356" y="2847891"/>
            <a:ext cx="3225681" cy="678788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05907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2790" y="569580"/>
            <a:ext cx="6546235" cy="20678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2791" y="2622536"/>
            <a:ext cx="3210857" cy="1285265"/>
          </a:xfrm>
        </p:spPr>
        <p:txBody>
          <a:bodyPr anchor="b"/>
          <a:lstStyle>
            <a:lvl1pPr marL="0" indent="0">
              <a:buNone/>
              <a:defRPr sz="1992" b="1"/>
            </a:lvl1pPr>
            <a:lvl2pPr marL="379476" indent="0">
              <a:buNone/>
              <a:defRPr sz="1660" b="1"/>
            </a:lvl2pPr>
            <a:lvl3pPr marL="758952" indent="0">
              <a:buNone/>
              <a:defRPr sz="1494" b="1"/>
            </a:lvl3pPr>
            <a:lvl4pPr marL="1138428" indent="0">
              <a:buNone/>
              <a:defRPr sz="1328" b="1"/>
            </a:lvl4pPr>
            <a:lvl5pPr marL="1517904" indent="0">
              <a:buNone/>
              <a:defRPr sz="1328" b="1"/>
            </a:lvl5pPr>
            <a:lvl6pPr marL="1897380" indent="0">
              <a:buNone/>
              <a:defRPr sz="1328" b="1"/>
            </a:lvl6pPr>
            <a:lvl7pPr marL="2276856" indent="0">
              <a:buNone/>
              <a:defRPr sz="1328" b="1"/>
            </a:lvl7pPr>
            <a:lvl8pPr marL="2656332" indent="0">
              <a:buNone/>
              <a:defRPr sz="1328" b="1"/>
            </a:lvl8pPr>
            <a:lvl9pPr marL="3035808" indent="0">
              <a:buNone/>
              <a:defRPr sz="132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2791" y="3907801"/>
            <a:ext cx="3210857" cy="574778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42356" y="2622536"/>
            <a:ext cx="3226670" cy="1285265"/>
          </a:xfrm>
        </p:spPr>
        <p:txBody>
          <a:bodyPr anchor="b"/>
          <a:lstStyle>
            <a:lvl1pPr marL="0" indent="0">
              <a:buNone/>
              <a:defRPr sz="1992" b="1"/>
            </a:lvl1pPr>
            <a:lvl2pPr marL="379476" indent="0">
              <a:buNone/>
              <a:defRPr sz="1660" b="1"/>
            </a:lvl2pPr>
            <a:lvl3pPr marL="758952" indent="0">
              <a:buNone/>
              <a:defRPr sz="1494" b="1"/>
            </a:lvl3pPr>
            <a:lvl4pPr marL="1138428" indent="0">
              <a:buNone/>
              <a:defRPr sz="1328" b="1"/>
            </a:lvl4pPr>
            <a:lvl5pPr marL="1517904" indent="0">
              <a:buNone/>
              <a:defRPr sz="1328" b="1"/>
            </a:lvl5pPr>
            <a:lvl6pPr marL="1897380" indent="0">
              <a:buNone/>
              <a:defRPr sz="1328" b="1"/>
            </a:lvl6pPr>
            <a:lvl7pPr marL="2276856" indent="0">
              <a:buNone/>
              <a:defRPr sz="1328" b="1"/>
            </a:lvl7pPr>
            <a:lvl8pPr marL="2656332" indent="0">
              <a:buNone/>
              <a:defRPr sz="1328" b="1"/>
            </a:lvl8pPr>
            <a:lvl9pPr marL="3035808" indent="0">
              <a:buNone/>
              <a:defRPr sz="132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42356" y="3907801"/>
            <a:ext cx="3226670" cy="574778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02272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5154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56342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2790" y="713211"/>
            <a:ext cx="2447920" cy="2496238"/>
          </a:xfrm>
        </p:spPr>
        <p:txBody>
          <a:bodyPr anchor="b"/>
          <a:lstStyle>
            <a:lvl1pPr>
              <a:defRPr sz="265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26670" y="1540340"/>
            <a:ext cx="3842355" cy="7602630"/>
          </a:xfrm>
        </p:spPr>
        <p:txBody>
          <a:bodyPr/>
          <a:lstStyle>
            <a:lvl1pPr>
              <a:defRPr sz="2656"/>
            </a:lvl1pPr>
            <a:lvl2pPr>
              <a:defRPr sz="2324"/>
            </a:lvl2pPr>
            <a:lvl3pPr>
              <a:defRPr sz="1992"/>
            </a:lvl3pPr>
            <a:lvl4pPr>
              <a:defRPr sz="1660"/>
            </a:lvl4pPr>
            <a:lvl5pPr>
              <a:defRPr sz="1660"/>
            </a:lvl5pPr>
            <a:lvl6pPr>
              <a:defRPr sz="1660"/>
            </a:lvl6pPr>
            <a:lvl7pPr>
              <a:defRPr sz="1660"/>
            </a:lvl7pPr>
            <a:lvl8pPr>
              <a:defRPr sz="1660"/>
            </a:lvl8pPr>
            <a:lvl9pPr>
              <a:defRPr sz="166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2790" y="3209449"/>
            <a:ext cx="2447920" cy="5945901"/>
          </a:xfrm>
        </p:spPr>
        <p:txBody>
          <a:bodyPr/>
          <a:lstStyle>
            <a:lvl1pPr marL="0" indent="0">
              <a:buNone/>
              <a:defRPr sz="1328"/>
            </a:lvl1pPr>
            <a:lvl2pPr marL="379476" indent="0">
              <a:buNone/>
              <a:defRPr sz="1162"/>
            </a:lvl2pPr>
            <a:lvl3pPr marL="758952" indent="0">
              <a:buNone/>
              <a:defRPr sz="996"/>
            </a:lvl3pPr>
            <a:lvl4pPr marL="1138428" indent="0">
              <a:buNone/>
              <a:defRPr sz="830"/>
            </a:lvl4pPr>
            <a:lvl5pPr marL="1517904" indent="0">
              <a:buNone/>
              <a:defRPr sz="830"/>
            </a:lvl5pPr>
            <a:lvl6pPr marL="1897380" indent="0">
              <a:buNone/>
              <a:defRPr sz="830"/>
            </a:lvl6pPr>
            <a:lvl7pPr marL="2276856" indent="0">
              <a:buNone/>
              <a:defRPr sz="830"/>
            </a:lvl7pPr>
            <a:lvl8pPr marL="2656332" indent="0">
              <a:buNone/>
              <a:defRPr sz="830"/>
            </a:lvl8pPr>
            <a:lvl9pPr marL="3035808" indent="0">
              <a:buNone/>
              <a:defRPr sz="83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9717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2790" y="713211"/>
            <a:ext cx="2447920" cy="2496238"/>
          </a:xfrm>
        </p:spPr>
        <p:txBody>
          <a:bodyPr anchor="b"/>
          <a:lstStyle>
            <a:lvl1pPr>
              <a:defRPr sz="265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26670" y="1540340"/>
            <a:ext cx="3842355" cy="7602630"/>
          </a:xfrm>
        </p:spPr>
        <p:txBody>
          <a:bodyPr anchor="t"/>
          <a:lstStyle>
            <a:lvl1pPr marL="0" indent="0">
              <a:buNone/>
              <a:defRPr sz="2656"/>
            </a:lvl1pPr>
            <a:lvl2pPr marL="379476" indent="0">
              <a:buNone/>
              <a:defRPr sz="2324"/>
            </a:lvl2pPr>
            <a:lvl3pPr marL="758952" indent="0">
              <a:buNone/>
              <a:defRPr sz="1992"/>
            </a:lvl3pPr>
            <a:lvl4pPr marL="1138428" indent="0">
              <a:buNone/>
              <a:defRPr sz="1660"/>
            </a:lvl4pPr>
            <a:lvl5pPr marL="1517904" indent="0">
              <a:buNone/>
              <a:defRPr sz="1660"/>
            </a:lvl5pPr>
            <a:lvl6pPr marL="1897380" indent="0">
              <a:buNone/>
              <a:defRPr sz="1660"/>
            </a:lvl6pPr>
            <a:lvl7pPr marL="2276856" indent="0">
              <a:buNone/>
              <a:defRPr sz="1660"/>
            </a:lvl7pPr>
            <a:lvl8pPr marL="2656332" indent="0">
              <a:buNone/>
              <a:defRPr sz="1660"/>
            </a:lvl8pPr>
            <a:lvl9pPr marL="3035808" indent="0">
              <a:buNone/>
              <a:defRPr sz="166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2790" y="3209449"/>
            <a:ext cx="2447920" cy="5945901"/>
          </a:xfrm>
        </p:spPr>
        <p:txBody>
          <a:bodyPr/>
          <a:lstStyle>
            <a:lvl1pPr marL="0" indent="0">
              <a:buNone/>
              <a:defRPr sz="1328"/>
            </a:lvl1pPr>
            <a:lvl2pPr marL="379476" indent="0">
              <a:buNone/>
              <a:defRPr sz="1162"/>
            </a:lvl2pPr>
            <a:lvl3pPr marL="758952" indent="0">
              <a:buNone/>
              <a:defRPr sz="996"/>
            </a:lvl3pPr>
            <a:lvl4pPr marL="1138428" indent="0">
              <a:buNone/>
              <a:defRPr sz="830"/>
            </a:lvl4pPr>
            <a:lvl5pPr marL="1517904" indent="0">
              <a:buNone/>
              <a:defRPr sz="830"/>
            </a:lvl5pPr>
            <a:lvl6pPr marL="1897380" indent="0">
              <a:buNone/>
              <a:defRPr sz="830"/>
            </a:lvl6pPr>
            <a:lvl7pPr marL="2276856" indent="0">
              <a:buNone/>
              <a:defRPr sz="830"/>
            </a:lvl7pPr>
            <a:lvl8pPr marL="2656332" indent="0">
              <a:buNone/>
              <a:defRPr sz="830"/>
            </a:lvl8pPr>
            <a:lvl9pPr marL="3035808" indent="0">
              <a:buNone/>
              <a:defRPr sz="83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470210-E710-44EA-8DF9-5226E47B3D76}" type="datetimeFigureOut">
              <a:rPr lang="en-US" smtClean="0"/>
              <a:t>8/2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2195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21802" y="569580"/>
            <a:ext cx="6546235" cy="20678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1802" y="2847891"/>
            <a:ext cx="6546235" cy="678788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21801" y="9915615"/>
            <a:ext cx="1707714" cy="5695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470210-E710-44EA-8DF9-5226E47B3D76}" type="datetimeFigureOut">
              <a:rPr lang="en-US" smtClean="0"/>
              <a:t>8/2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14134" y="9915615"/>
            <a:ext cx="2561570" cy="5695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60323" y="9915615"/>
            <a:ext cx="1707714" cy="5695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6CF797-84AC-4C12-A5DB-ABAD3377BA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11070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8952" rtl="0" eaLnBrk="1" latinLnBrk="0" hangingPunct="1">
        <a:lnSpc>
          <a:spcPct val="90000"/>
        </a:lnSpc>
        <a:spcBef>
          <a:spcPct val="0"/>
        </a:spcBef>
        <a:buNone/>
        <a:defRPr sz="365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9738" indent="-189738" algn="l" defTabSz="758952" rtl="0" eaLnBrk="1" latinLnBrk="0" hangingPunct="1">
        <a:lnSpc>
          <a:spcPct val="90000"/>
        </a:lnSpc>
        <a:spcBef>
          <a:spcPts val="830"/>
        </a:spcBef>
        <a:buFont typeface="Arial" panose="020B0604020202020204" pitchFamily="34" charset="0"/>
        <a:buChar char="•"/>
        <a:defRPr sz="2324" kern="1200">
          <a:solidFill>
            <a:schemeClr val="tx1"/>
          </a:solidFill>
          <a:latin typeface="+mn-lt"/>
          <a:ea typeface="+mn-ea"/>
          <a:cs typeface="+mn-cs"/>
        </a:defRPr>
      </a:lvl1pPr>
      <a:lvl2pPr marL="569214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992" kern="1200">
          <a:solidFill>
            <a:schemeClr val="tx1"/>
          </a:solidFill>
          <a:latin typeface="+mn-lt"/>
          <a:ea typeface="+mn-ea"/>
          <a:cs typeface="+mn-cs"/>
        </a:defRPr>
      </a:lvl2pPr>
      <a:lvl3pPr marL="948690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660" kern="1200">
          <a:solidFill>
            <a:schemeClr val="tx1"/>
          </a:solidFill>
          <a:latin typeface="+mn-lt"/>
          <a:ea typeface="+mn-ea"/>
          <a:cs typeface="+mn-cs"/>
        </a:defRPr>
      </a:lvl3pPr>
      <a:lvl4pPr marL="1328166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4pPr>
      <a:lvl5pPr marL="1707642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5pPr>
      <a:lvl6pPr marL="2087118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6pPr>
      <a:lvl7pPr marL="2466594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7pPr>
      <a:lvl8pPr marL="2846070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8pPr>
      <a:lvl9pPr marL="3225546" indent="-189738" algn="l" defTabSz="758952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1pPr>
      <a:lvl2pPr marL="379476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2pPr>
      <a:lvl3pPr marL="758952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3pPr>
      <a:lvl4pPr marL="1138428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4pPr>
      <a:lvl5pPr marL="1517904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5pPr>
      <a:lvl6pPr marL="1897380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6pPr>
      <a:lvl7pPr marL="2276856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7pPr>
      <a:lvl8pPr marL="2656332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8pPr>
      <a:lvl9pPr marL="3035808" algn="l" defTabSz="758952" rtl="0" eaLnBrk="1" latinLnBrk="0" hangingPunct="1">
        <a:defRPr sz="149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 txBox="1">
            <a:spLocks/>
          </p:cNvSpPr>
          <p:nvPr/>
        </p:nvSpPr>
        <p:spPr>
          <a:xfrm>
            <a:off x="137319" y="6802659"/>
            <a:ext cx="7315200" cy="1031579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>
            <a:lvl1pPr algn="ctr" defTabSz="758952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98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sz="1200" b="1" smtClean="0">
                <a:latin typeface="Arial" panose="020B0604020202020204" pitchFamily="34" charset="0"/>
                <a:cs typeface="Arial" panose="020B0604020202020204" pitchFamily="34" charset="0"/>
              </a:rPr>
              <a:t>Additional file 1.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200" i="1" dirty="0">
                <a:latin typeface="Helvetica" panose="020B0604020202020204" pitchFamily="34" charset="0"/>
                <a:cs typeface="Helvetica" panose="020B0604020202020204" pitchFamily="34" charset="0"/>
              </a:rPr>
              <a:t>ERF8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expression in germinating seeds. Based on publicly available </a:t>
            </a:r>
            <a:r>
              <a:rPr lang="en-US" sz="1200" dirty="0" err="1">
                <a:latin typeface="Helvetica" panose="020B0604020202020204" pitchFamily="34" charset="0"/>
                <a:cs typeface="Helvetica" panose="020B0604020202020204" pitchFamily="34" charset="0"/>
              </a:rPr>
              <a:t>AtGenExpress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data from the Bio-Analytic Resource (BAR; </a:t>
            </a:r>
          </a:p>
          <a:p>
            <a:pPr algn="l"/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http://bar.utoronto.ca/efp/cgi-bin/efpWeb.cgi; Winter et al., 2007). Data from </a:t>
            </a:r>
            <a:r>
              <a:rPr lang="en-US" sz="1200" dirty="0" err="1">
                <a:latin typeface="Helvetica" panose="020B0604020202020204" pitchFamily="34" charset="0"/>
                <a:cs typeface="Helvetica" panose="020B0604020202020204" pitchFamily="34" charset="0"/>
              </a:rPr>
              <a:t>Narsai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 et al. (2011).</a:t>
            </a:r>
          </a:p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lang="en-CA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estern </a:t>
            </a:r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blot analysis showing protein expression of HA-tagged </a:t>
            </a:r>
            <a:r>
              <a:rPr lang="en-CA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RF8 after</a:t>
            </a:r>
            <a:r>
              <a:rPr lang="en-CA" sz="1200" dirty="0">
                <a:latin typeface="Arial" panose="020B0604020202020204" pitchFamily="34" charset="0"/>
                <a:cs typeface="Arial" panose="020B0604020202020204" pitchFamily="34" charset="0"/>
              </a:rPr>
              <a:t>. DEX treatment. 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440871" y="4454965"/>
            <a:ext cx="29292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  0       1        2       3      4       5       6       8</a:t>
            </a:r>
            <a:endParaRPr lang="en-CA" sz="1200" dirty="0"/>
          </a:p>
        </p:txBody>
      </p:sp>
      <p:sp>
        <p:nvSpPr>
          <p:cNvPr id="6" name="TextBox 5"/>
          <p:cNvSpPr txBox="1"/>
          <p:nvPr/>
        </p:nvSpPr>
        <p:spPr>
          <a:xfrm>
            <a:off x="1460077" y="4454965"/>
            <a:ext cx="11112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 smtClean="0"/>
              <a:t>Hour post DEX</a:t>
            </a:r>
            <a:endParaRPr lang="en-CA" sz="1200" dirty="0"/>
          </a:p>
        </p:txBody>
      </p:sp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V="1">
            <a:off x="2574727" y="4716434"/>
            <a:ext cx="2411506" cy="145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781" t="41820" r="28834" b="53517"/>
          <a:stretch/>
        </p:blipFill>
        <p:spPr>
          <a:xfrm flipV="1">
            <a:off x="2589166" y="4866621"/>
            <a:ext cx="2411506" cy="378132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 flipV="1">
            <a:off x="2574727" y="4704796"/>
            <a:ext cx="2411506" cy="54311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10" name="TextBox 9"/>
          <p:cNvSpPr txBox="1"/>
          <p:nvPr/>
        </p:nvSpPr>
        <p:spPr>
          <a:xfrm>
            <a:off x="1854530" y="4699356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 smtClean="0"/>
              <a:t>ERF8</a:t>
            </a:r>
          </a:p>
        </p:txBody>
      </p:sp>
      <p:sp>
        <p:nvSpPr>
          <p:cNvPr id="11" name="Rectangle 10"/>
          <p:cNvSpPr/>
          <p:nvPr/>
        </p:nvSpPr>
        <p:spPr>
          <a:xfrm>
            <a:off x="1854530" y="4917187"/>
            <a:ext cx="72019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sz="1200" dirty="0" err="1"/>
              <a:t>Ponceau</a:t>
            </a:r>
            <a:endParaRPr lang="en-CA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320860" y="75315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CA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20860" y="427756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CA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56" t="35572" r="8702" b="23620"/>
          <a:stretch/>
        </p:blipFill>
        <p:spPr bwMode="auto">
          <a:xfrm>
            <a:off x="806740" y="969869"/>
            <a:ext cx="5947479" cy="23352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4130137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730</TotalTime>
  <Words>78</Words>
  <Application>Microsoft Office PowerPoint</Application>
  <PresentationFormat>Custom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ne</dc:creator>
  <cp:lastModifiedBy>moeder</cp:lastModifiedBy>
  <cp:revision>315</cp:revision>
  <dcterms:created xsi:type="dcterms:W3CDTF">2016-09-27T17:34:00Z</dcterms:created>
  <dcterms:modified xsi:type="dcterms:W3CDTF">2018-08-21T22:23:28Z</dcterms:modified>
</cp:coreProperties>
</file>